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9F4A24-0AE1-4519-85DB-A43D87E1E32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69A2A1-FE44-4595-996F-A91BA4D1D04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78F8A6-28AC-4FD0-A826-C09E39F5195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DCFE78-7C11-42F8-8A9E-15ABB8B6956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AFEDB6-2ED5-47E4-A295-B27933C20E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4B9262-6C94-4204-810E-915BD0871EC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183933-A258-4A2F-B7AA-5BAED2249F6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81E62E-3288-4886-8809-886A9B05B10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359B9E-F189-43D6-A0CC-6E63E0A52F4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7DCEB8-7647-4106-A768-7FAD6067E6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BB05AC-12EB-4004-8C08-FA3EABEAE1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E43B1F-4065-4DF1-A6BD-64EE3E1A82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7732C63-8A7B-4F0D-9C03-98892E4AF6EC}" type="slidenum">
              <a:rPr b="0" lang="zh-TW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文字方塊 3"/>
          <p:cNvSpPr/>
          <p:nvPr/>
        </p:nvSpPr>
        <p:spPr>
          <a:xfrm>
            <a:off x="1361520" y="1916280"/>
            <a:ext cx="205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giogenesis arra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文字方塊 32"/>
          <p:cNvSpPr/>
          <p:nvPr/>
        </p:nvSpPr>
        <p:spPr>
          <a:xfrm>
            <a:off x="207000" y="1636560"/>
            <a:ext cx="282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圖片 15" descr=""/>
          <p:cNvPicPr/>
          <p:nvPr/>
        </p:nvPicPr>
        <p:blipFill>
          <a:blip r:embed="rId1"/>
          <a:stretch/>
        </p:blipFill>
        <p:spPr>
          <a:xfrm>
            <a:off x="1047600" y="2633760"/>
            <a:ext cx="2908440" cy="1011240"/>
          </a:xfrm>
          <a:prstGeom prst="rect">
            <a:avLst/>
          </a:prstGeom>
          <a:ln w="0">
            <a:noFill/>
          </a:ln>
        </p:spPr>
      </p:pic>
      <p:sp>
        <p:nvSpPr>
          <p:cNvPr id="44" name="文字方塊 5"/>
          <p:cNvSpPr/>
          <p:nvPr/>
        </p:nvSpPr>
        <p:spPr>
          <a:xfrm>
            <a:off x="2011320" y="2333520"/>
            <a:ext cx="736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ehicl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文字方塊 20"/>
          <p:cNvSpPr/>
          <p:nvPr/>
        </p:nvSpPr>
        <p:spPr>
          <a:xfrm>
            <a:off x="1437480" y="3860640"/>
            <a:ext cx="1540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BT-143-S-F6F7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矩形 25"/>
          <p:cNvSpPr/>
          <p:nvPr/>
        </p:nvSpPr>
        <p:spPr>
          <a:xfrm>
            <a:off x="2790000" y="3860640"/>
            <a:ext cx="798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 </a:t>
            </a:r>
            <a:r>
              <a:rPr b="0" lang="el-GR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μ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/m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文字方塊 4"/>
          <p:cNvSpPr/>
          <p:nvPr/>
        </p:nvSpPr>
        <p:spPr>
          <a:xfrm>
            <a:off x="6104160" y="1916280"/>
            <a:ext cx="1748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poptosis arra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文字方塊 1"/>
          <p:cNvSpPr/>
          <p:nvPr/>
        </p:nvSpPr>
        <p:spPr>
          <a:xfrm>
            <a:off x="4666320" y="170028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文字方塊 1"/>
          <p:cNvSpPr/>
          <p:nvPr/>
        </p:nvSpPr>
        <p:spPr>
          <a:xfrm>
            <a:off x="179280" y="550800"/>
            <a:ext cx="82803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. Angiogenesis and apoptosis array analysis of CBT-143-S-F6F7-treated Huh7 cell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圖片 74" descr=""/>
          <p:cNvPicPr/>
          <p:nvPr/>
        </p:nvPicPr>
        <p:blipFill>
          <a:blip r:embed="rId2"/>
          <a:stretch/>
        </p:blipFill>
        <p:spPr>
          <a:xfrm>
            <a:off x="1047600" y="4218120"/>
            <a:ext cx="2908440" cy="1012680"/>
          </a:xfrm>
          <a:prstGeom prst="rect">
            <a:avLst/>
          </a:prstGeom>
          <a:ln w="0">
            <a:noFill/>
          </a:ln>
        </p:spPr>
      </p:pic>
      <p:grpSp>
        <p:nvGrpSpPr>
          <p:cNvPr id="51" name="群組 1"/>
          <p:cNvGrpSpPr/>
          <p:nvPr/>
        </p:nvGrpSpPr>
        <p:grpSpPr>
          <a:xfrm>
            <a:off x="5842080" y="1712880"/>
            <a:ext cx="2228760" cy="4378320"/>
            <a:chOff x="5842080" y="1712880"/>
            <a:chExt cx="2228760" cy="4378320"/>
          </a:xfrm>
        </p:grpSpPr>
        <p:pic>
          <p:nvPicPr>
            <p:cNvPr id="52" name="圖片 109" descr=""/>
            <p:cNvPicPr/>
            <p:nvPr/>
          </p:nvPicPr>
          <p:blipFill>
            <a:blip r:embed="rId3"/>
            <a:stretch/>
          </p:blipFill>
          <p:spPr>
            <a:xfrm>
              <a:off x="5842080" y="2163600"/>
              <a:ext cx="2228760" cy="1539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3" name="文字方塊 5"/>
            <p:cNvSpPr/>
            <p:nvPr/>
          </p:nvSpPr>
          <p:spPr>
            <a:xfrm>
              <a:off x="6640560" y="1712880"/>
              <a:ext cx="736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Vehicl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文字方塊 20"/>
            <p:cNvSpPr/>
            <p:nvPr/>
          </p:nvSpPr>
          <p:spPr>
            <a:xfrm>
              <a:off x="5928480" y="4059000"/>
              <a:ext cx="1540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BT-143-S-F6F7 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矩形 25"/>
            <p:cNvSpPr/>
            <p:nvPr/>
          </p:nvSpPr>
          <p:spPr>
            <a:xfrm>
              <a:off x="7111080" y="4040280"/>
              <a:ext cx="798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 </a:t>
              </a:r>
              <a:r>
                <a:rPr b="0" lang="el-GR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μ</a:t>
              </a: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/mL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6" name="圖片 91" descr=""/>
            <p:cNvPicPr/>
            <p:nvPr/>
          </p:nvPicPr>
          <p:blipFill>
            <a:blip r:embed="rId4"/>
            <a:stretch/>
          </p:blipFill>
          <p:spPr>
            <a:xfrm>
              <a:off x="5842080" y="4552200"/>
              <a:ext cx="2228760" cy="153900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7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郭宗鏗</dc:creator>
  <dc:description/>
  <dc:language>en-US</dc:language>
  <cp:lastModifiedBy>郭宗鏗</cp:lastModifiedBy>
  <dcterms:modified xsi:type="dcterms:W3CDTF">2015-11-03T06:49:57Z</dcterms:modified>
  <cp:revision>274</cp:revision>
  <dc:subject/>
  <dc:title>PowerPoint 簡報</dc:title>
</cp:coreProperties>
</file>